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9" r:id="rId2"/>
    <p:sldId id="258" r:id="rId3"/>
    <p:sldId id="257" r:id="rId4"/>
    <p:sldId id="261" r:id="rId5"/>
    <p:sldId id="262" r:id="rId6"/>
    <p:sldId id="265" r:id="rId7"/>
    <p:sldId id="267" r:id="rId8"/>
  </p:sldIdLst>
  <p:sldSz cx="12192000" cy="6858000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5401"/>
    <p:restoredTop sz="92762"/>
  </p:normalViewPr>
  <p:slideViewPr>
    <p:cSldViewPr snapToGrid="0" snapToObjects="1">
      <p:cViewPr varScale="1">
        <p:scale>
          <a:sx n="82" d="100"/>
          <a:sy n="82" d="100"/>
        </p:scale>
        <p:origin x="240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BAEC7E-1000-994E-B899-136B6F9E085B}" type="datetimeFigureOut">
              <a:rPr lang="it-IT" smtClean="0"/>
              <a:t>25/10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161534-5C56-D840-AADA-DDF8C255D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707803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est plot of risk difference (RD) for venous thromboembolism (VTE) among COVID-19 patients compared to non-COVID-19 patients</a:t>
            </a:r>
            <a:r>
              <a:rPr lang="en-US" noProof="0" dirty="0">
                <a:effectLst/>
              </a:rPr>
              <a:t> in prospective studies</a:t>
            </a:r>
            <a:endParaRPr lang="en-US" noProof="0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161534-5C56-D840-AADA-DDF8C255D1AF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834722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est plot of risk difference (RD) for venous thromboembolism (VTE) among COVID-19 patients compared to non-COVID-19 patients</a:t>
            </a:r>
            <a:r>
              <a:rPr lang="en-US" noProof="0" dirty="0">
                <a:effectLst/>
              </a:rPr>
              <a:t> in emergency ward</a:t>
            </a:r>
            <a:endParaRPr lang="en-US" noProof="0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161534-5C56-D840-AADA-DDF8C255D1AF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3060557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est plot of risk difference (RD) for venous thromboembolism (VTE) among COVID-19 patients compared to non-COVID-19 patients</a:t>
            </a:r>
            <a:r>
              <a:rPr lang="en-US" noProof="0" dirty="0">
                <a:effectLst/>
              </a:rPr>
              <a:t> affected by influenza</a:t>
            </a:r>
            <a:endParaRPr lang="en-US" noProof="0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161534-5C56-D840-AADA-DDF8C255D1AF}" type="slidenum">
              <a:rPr lang="it-IT" smtClean="0"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5750255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est plot of risk difference (RD) for pulmonary embolism (PE) among COVID-19 patients compared to non-COVID-19 patients in </a:t>
            </a:r>
            <a:r>
              <a:rPr lang="en-US" noProof="0" dirty="0">
                <a:effectLst/>
              </a:rPr>
              <a:t> prospective studies</a:t>
            </a:r>
            <a:endParaRPr lang="en-US" noProof="0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161534-5C56-D840-AADA-DDF8C255D1AF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542544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est plot of risk difference (RD) for pulmonary embolism (PE) among COVID-19 patients compared to non-COVID-19 patients in emergency ward</a:t>
            </a:r>
            <a:endParaRPr lang="en-US" noProof="0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161534-5C56-D840-AADA-DDF8C255D1AF}" type="slidenum">
              <a:rPr lang="it-IT" smtClean="0"/>
              <a:t>5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952111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est plot of risk difference (RD) for deep venous thrombosis (DVT) among COVID-19 patients compared to non-COVID-19 patients in prospective studies.</a:t>
            </a:r>
            <a:r>
              <a:rPr lang="en-US" noProof="0" dirty="0">
                <a:effectLst/>
              </a:rPr>
              <a:t> </a:t>
            </a:r>
            <a:endParaRPr lang="en-US" noProof="0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161534-5C56-D840-AADA-DDF8C255D1AF}" type="slidenum">
              <a:rPr lang="it-IT" smtClean="0"/>
              <a:t>6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4592233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pper box: Forest plot of risk difference (RD) for deep venous thrombosis (DVT) among COVID-19 patients compared to non-COVID-19 patients in </a:t>
            </a:r>
            <a:r>
              <a:rPr lang="en-US" sz="1200" kern="1200" noProof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tenisve</a:t>
            </a:r>
            <a:r>
              <a:rPr lang="en-US" sz="1200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are unit.</a:t>
            </a:r>
          </a:p>
          <a:p>
            <a:r>
              <a:rPr lang="en-US" sz="1200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ower box: </a:t>
            </a:r>
            <a:r>
              <a:rPr lang="en-US" noProof="0" dirty="0">
                <a:effectLst/>
              </a:rPr>
              <a:t> </a:t>
            </a:r>
            <a:r>
              <a:rPr lang="en-US" sz="1200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est plot of risk difference (RD) for deep venous thrombosis (DVT) among COVID-19 patients compared to non-COVID-19 patients affected by influenza.</a:t>
            </a:r>
            <a:r>
              <a:rPr lang="en-US" noProof="0" dirty="0">
                <a:effectLst/>
              </a:rPr>
              <a:t> </a:t>
            </a:r>
            <a:endParaRPr lang="en-US" noProof="0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161534-5C56-D840-AADA-DDF8C255D1AF}" type="slidenum">
              <a:rPr lang="it-IT" smtClean="0"/>
              <a:t>7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2637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6A4CA98E-D90E-2841-BDEA-E47DF337E3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xmlns="" id="{C8D26627-206E-E541-87FA-7B42C50257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80B3F6A0-B017-E04A-88C4-6CC3FAF9C4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8770-7E62-E04C-8AF0-3B777E6A3FF8}" type="datetimeFigureOut">
              <a:rPr lang="it-IT" smtClean="0"/>
              <a:t>25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12437570-00C9-6241-B758-F5FA64360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6EC5B520-5369-E34F-8DEA-B7A0C0803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3FA3-4694-A44F-ACDC-9109A4CFDDB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24907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CFB5029C-2D11-FF49-B1DF-85F6B0FBB1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xmlns="" id="{B37EE35D-CA6B-FB4C-901F-58A3C575F8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37D55C3E-4977-984D-85BF-48E62717DF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8770-7E62-E04C-8AF0-3B777E6A3FF8}" type="datetimeFigureOut">
              <a:rPr lang="it-IT" smtClean="0"/>
              <a:t>25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292AFCAC-0C5F-0F47-8096-05F72A958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721CD4CF-E0C8-404C-BB85-00209E399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3FA3-4694-A44F-ACDC-9109A4CFDDB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64704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xmlns="" id="{76C26605-AE32-E44A-ABC7-8246AE9FC9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xmlns="" id="{67B61A50-7353-AA4B-B36F-1B984B2788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7AA3BDCB-E5A5-A646-BDE5-CAD0A7E4A0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8770-7E62-E04C-8AF0-3B777E6A3FF8}" type="datetimeFigureOut">
              <a:rPr lang="it-IT" smtClean="0"/>
              <a:t>25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F040D6D5-60A6-1546-9012-8A38A42FC2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A67F6703-198D-2B46-8E13-94682045A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3FA3-4694-A44F-ACDC-9109A4CFDDB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7730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2F626A55-FA2D-604B-923B-39E6418C3E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4D2D17FC-9457-D544-B755-501143786C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7E59CF39-D816-194F-BD76-7311A705A2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8770-7E62-E04C-8AF0-3B777E6A3FF8}" type="datetimeFigureOut">
              <a:rPr lang="it-IT" smtClean="0"/>
              <a:t>25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C7EE7F99-09C8-9A41-8C6A-A9B212F6B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2A3F5F6B-9538-184D-A2AA-878E5B3D22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3FA3-4694-A44F-ACDC-9109A4CFDDB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20708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66755EB2-C322-D44B-9E72-2B2DD41CB7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xmlns="" id="{E6AF2196-4144-A041-982A-49507E425D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30AA0A4E-0362-0842-B9B3-E9EF41556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8770-7E62-E04C-8AF0-3B777E6A3FF8}" type="datetimeFigureOut">
              <a:rPr lang="it-IT" smtClean="0"/>
              <a:t>25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316F0A63-EFB4-4549-A7F1-31C71D90BA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4895CA73-A4B4-5D42-87B1-EB9A9FE11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3FA3-4694-A44F-ACDC-9109A4CFDDB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05621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4C38F537-111E-4340-8149-6EC8E1BDBD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8BB0891D-A2C2-4544-BEF2-FB39BBEED3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xmlns="" id="{64A9904B-421C-1948-8D3A-51C41FC7D7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xmlns="" id="{1EF0E247-15CE-7649-BC00-83966504F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8770-7E62-E04C-8AF0-3B777E6A3FF8}" type="datetimeFigureOut">
              <a:rPr lang="it-IT" smtClean="0"/>
              <a:t>25/10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xmlns="" id="{EEE56F21-CFD9-DB42-8EFD-6136109D0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xmlns="" id="{50DCDF44-6B30-294F-B2E5-19306CFBA8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3FA3-4694-A44F-ACDC-9109A4CFDDB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1683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75FB1CEF-D6FC-6441-A88D-6AA949D923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xmlns="" id="{382686F4-2D99-8343-8116-6B04C3347D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xmlns="" id="{21B1617C-12AD-3241-AF6F-13BA129F21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xmlns="" id="{B568D97B-22AC-F44C-B641-6DE63B1EC2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xmlns="" id="{93A70864-2756-D64E-9585-56D7B7A3C0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xmlns="" id="{F9D84BDC-0758-3849-84A9-A7700E322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8770-7E62-E04C-8AF0-3B777E6A3FF8}" type="datetimeFigureOut">
              <a:rPr lang="it-IT" smtClean="0"/>
              <a:t>25/10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xmlns="" id="{19B68D54-AA2C-6041-B98F-4BA836DFF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xmlns="" id="{68EE68A2-7CF3-F740-9B63-8B6C510AB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3FA3-4694-A44F-ACDC-9109A4CFDDB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1168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4740D2E2-A51E-6A43-9166-A447A91CA5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xmlns="" id="{55F68D46-66BE-184D-B392-C53CB0592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8770-7E62-E04C-8AF0-3B777E6A3FF8}" type="datetimeFigureOut">
              <a:rPr lang="it-IT" smtClean="0"/>
              <a:t>25/10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xmlns="" id="{9A49F5A1-E176-C745-90A6-5A4DBECBCE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xmlns="" id="{4B4522B7-03E0-8F4A-A299-0E3AAE203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3FA3-4694-A44F-ACDC-9109A4CFDDB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7486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xmlns="" id="{9E386535-B4C6-D44C-A643-3863DFDF9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8770-7E62-E04C-8AF0-3B777E6A3FF8}" type="datetimeFigureOut">
              <a:rPr lang="it-IT" smtClean="0"/>
              <a:t>25/10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xmlns="" id="{5AD07399-593E-DB49-ADBC-0B8274895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xmlns="" id="{E233123D-23DD-334E-937F-F1860E72E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3FA3-4694-A44F-ACDC-9109A4CFDDB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401667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15C5DC52-C840-2541-B821-CA3DA7ECE4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9119AE13-85B5-6546-ACC3-C4728C2AAF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xmlns="" id="{97E06F08-7FCD-D849-9559-CDAA362A29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xmlns="" id="{E1D2E38D-00E2-5645-8F71-38DC277411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8770-7E62-E04C-8AF0-3B777E6A3FF8}" type="datetimeFigureOut">
              <a:rPr lang="it-IT" smtClean="0"/>
              <a:t>25/10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xmlns="" id="{F9B6A038-2673-7549-8CA7-1C62B6F59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xmlns="" id="{E4E52BBD-4F29-1A43-A10F-F46DA4ADBC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3FA3-4694-A44F-ACDC-9109A4CFDDB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1180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F1263C58-EE3A-F642-8651-DE353F0E80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xmlns="" id="{6FC601DD-815D-B84B-8184-294700E06E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xmlns="" id="{A4C57D7B-D05A-2443-9102-A3F2C26564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xmlns="" id="{B55293BE-7F3C-874F-9B90-8E7B4E239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18770-7E62-E04C-8AF0-3B777E6A3FF8}" type="datetimeFigureOut">
              <a:rPr lang="it-IT" smtClean="0"/>
              <a:t>25/10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xmlns="" id="{9DCAE30C-12C9-D649-9941-5DA134E39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xmlns="" id="{DE6FC243-2CB3-334F-912C-F4FB189078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3FA3-4694-A44F-ACDC-9109A4CFDDB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92231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xmlns="" id="{312F4047-7A18-644F-8FC3-CECB60F761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xmlns="" id="{0ABF4B7C-17BF-CA40-A4B6-9AA8565E45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0C2A0AEA-D3F7-F742-8918-C3BE2E41A1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318770-7E62-E04C-8AF0-3B777E6A3FF8}" type="datetimeFigureOut">
              <a:rPr lang="it-IT" smtClean="0"/>
              <a:t>25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C4DE1901-18FE-EC4E-9272-EBF413C611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2E4C0C5F-AEF7-EA4D-A340-D81291A453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603FA3-4694-A44F-ACDC-9109A4CFDDB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1166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emf"/><Relationship Id="rId5" Type="http://schemas.openxmlformats.org/officeDocument/2006/relationships/image" Target="../media/image15.png"/><Relationship Id="rId4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magine 10">
            <a:extLst>
              <a:ext uri="{FF2B5EF4-FFF2-40B4-BE49-F238E27FC236}">
                <a16:creationId xmlns:a16="http://schemas.microsoft.com/office/drawing/2014/main" xmlns="" id="{8DAF3333-2FAE-B143-AA0C-9EC9B6A5F4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6746" y="4210722"/>
            <a:ext cx="4134947" cy="1525988"/>
          </a:xfrm>
          <a:prstGeom prst="rect">
            <a:avLst/>
          </a:prstGeom>
        </p:spPr>
      </p:pic>
      <p:pic>
        <p:nvPicPr>
          <p:cNvPr id="13" name="Immagine 12">
            <a:extLst>
              <a:ext uri="{FF2B5EF4-FFF2-40B4-BE49-F238E27FC236}">
                <a16:creationId xmlns:a16="http://schemas.microsoft.com/office/drawing/2014/main" xmlns="" id="{7A1072CF-2939-1D43-A842-A92CE5D5298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6747" y="568170"/>
            <a:ext cx="9676660" cy="3342445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xmlns="" id="{68C44CDB-893B-4E53-B282-367AFA186DE9}"/>
              </a:ext>
            </a:extLst>
          </p:cNvPr>
          <p:cNvSpPr txBox="1"/>
          <p:nvPr/>
        </p:nvSpPr>
        <p:spPr>
          <a:xfrm>
            <a:off x="701336" y="6036816"/>
            <a:ext cx="898355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kern="1200" noProof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est plot of risk difference (RD) for venous thromboembolism (VTE) among COVID-19 patients compared to non-COVID-19 patients</a:t>
            </a:r>
            <a:r>
              <a:rPr lang="en-US" sz="1000" noProof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in prospective </a:t>
            </a:r>
            <a:r>
              <a:rPr lang="en-US" sz="1000" noProof="0" dirty="0" smtClean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udies.</a:t>
            </a:r>
            <a:endParaRPr lang="en-US" sz="1000" noProof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it-IT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1022031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magine 10">
            <a:extLst>
              <a:ext uri="{FF2B5EF4-FFF2-40B4-BE49-F238E27FC236}">
                <a16:creationId xmlns:a16="http://schemas.microsoft.com/office/drawing/2014/main" xmlns="" id="{A49685AC-D3F4-A142-942F-E93BAFC7B3A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8171" y="4251482"/>
            <a:ext cx="4671030" cy="1437698"/>
          </a:xfrm>
          <a:prstGeom prst="rect">
            <a:avLst/>
          </a:prstGeom>
        </p:spPr>
      </p:pic>
      <p:pic>
        <p:nvPicPr>
          <p:cNvPr id="13" name="Immagine 12">
            <a:extLst>
              <a:ext uri="{FF2B5EF4-FFF2-40B4-BE49-F238E27FC236}">
                <a16:creationId xmlns:a16="http://schemas.microsoft.com/office/drawing/2014/main" xmlns="" id="{EA650D9E-7B7D-7F43-B039-7C896FF2357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6128" y="531065"/>
            <a:ext cx="10972800" cy="2921000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xmlns="" id="{470DE782-F702-4567-9F77-447B0FE11696}"/>
              </a:ext>
            </a:extLst>
          </p:cNvPr>
          <p:cNvSpPr txBox="1"/>
          <p:nvPr/>
        </p:nvSpPr>
        <p:spPr>
          <a:xfrm>
            <a:off x="426128" y="6161108"/>
            <a:ext cx="885851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kern="1200" noProof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est plot of risk difference (RD) for venous thromboembolism (VTE) among COVID-19 patients compared to non-COVID-19 patients</a:t>
            </a:r>
            <a:r>
              <a:rPr lang="en-US" sz="1000" noProof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in emergency </a:t>
            </a:r>
            <a:r>
              <a:rPr lang="en-US" sz="1000" noProof="0" dirty="0" smtClean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ard.</a:t>
            </a:r>
            <a:endParaRPr lang="en-US" sz="1000" noProof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it-IT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5629245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xmlns="" id="{4D8113A8-F620-5145-83E2-97040C89AE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1134" y="3793448"/>
            <a:ext cx="4508534" cy="1489902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xmlns="" id="{FA2E422E-FD3F-5148-9949-FC41AD21E8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3479" y="313616"/>
            <a:ext cx="10448053" cy="3289300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xmlns="" id="{4EC7C54B-63AD-4536-8F72-B824E2AE0399}"/>
              </a:ext>
            </a:extLst>
          </p:cNvPr>
          <p:cNvSpPr txBox="1"/>
          <p:nvPr/>
        </p:nvSpPr>
        <p:spPr>
          <a:xfrm>
            <a:off x="266330" y="6329779"/>
            <a:ext cx="895950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000" kern="1200" noProof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Forest plot of risk difference (RD) for venous thromboembolism (VTE) among COVID-19 patients compared to non-COVID-19 patients</a:t>
            </a:r>
            <a:r>
              <a:rPr lang="en-US" sz="1000" noProof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ffected by </a:t>
            </a:r>
            <a:r>
              <a:rPr lang="en-US" sz="1000" noProof="0" dirty="0" smtClean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fluenza.</a:t>
            </a:r>
            <a:endParaRPr lang="en-US" sz="1000" noProof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7231279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magine 10">
            <a:extLst>
              <a:ext uri="{FF2B5EF4-FFF2-40B4-BE49-F238E27FC236}">
                <a16:creationId xmlns:a16="http://schemas.microsoft.com/office/drawing/2014/main" xmlns="" id="{87A8DA22-A7FD-1743-84AC-64666534086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9506" y="4051794"/>
            <a:ext cx="4878214" cy="1701800"/>
          </a:xfrm>
          <a:prstGeom prst="rect">
            <a:avLst/>
          </a:prstGeom>
        </p:spPr>
      </p:pic>
      <p:pic>
        <p:nvPicPr>
          <p:cNvPr id="13" name="Immagine 12">
            <a:extLst>
              <a:ext uri="{FF2B5EF4-FFF2-40B4-BE49-F238E27FC236}">
                <a16:creationId xmlns:a16="http://schemas.microsoft.com/office/drawing/2014/main" xmlns="" id="{69DA54C8-99BB-D54E-B71F-05E6CF6DB4A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9506" y="330200"/>
            <a:ext cx="10618614" cy="3098800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xmlns="" id="{D1E2D740-54B9-4EF6-8527-31BA4FE93352}"/>
              </a:ext>
            </a:extLst>
          </p:cNvPr>
          <p:cNvSpPr txBox="1"/>
          <p:nvPr/>
        </p:nvSpPr>
        <p:spPr>
          <a:xfrm>
            <a:off x="861134" y="6214370"/>
            <a:ext cx="867256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sz="1000" kern="1200" noProof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est plot of risk difference (RD) for pulmonary embolism (PE) among COVID-19 patients compared to non-COVID-19 patients in </a:t>
            </a:r>
            <a:r>
              <a:rPr lang="en-US" sz="1000" noProof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spective </a:t>
            </a:r>
            <a:r>
              <a:rPr lang="en-US" sz="1000" noProof="0" dirty="0" smtClean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udies.</a:t>
            </a:r>
            <a:endParaRPr lang="en-US" sz="1000" noProof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8780798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>
            <a:extLst>
              <a:ext uri="{FF2B5EF4-FFF2-40B4-BE49-F238E27FC236}">
                <a16:creationId xmlns:a16="http://schemas.microsoft.com/office/drawing/2014/main" xmlns="" id="{DE744CFC-34E6-B547-B5B9-8AE1EE9424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9709" y="4395780"/>
            <a:ext cx="4128116" cy="1371241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xmlns="" id="{3D5D57D7-FA04-C54A-A823-1AAF72E35B2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25117" y="550415"/>
            <a:ext cx="9908999" cy="3391270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xmlns="" id="{0E7C8583-3D87-4508-9E09-3FE1044AF2A6}"/>
              </a:ext>
            </a:extLst>
          </p:cNvPr>
          <p:cNvSpPr txBox="1"/>
          <p:nvPr/>
        </p:nvSpPr>
        <p:spPr>
          <a:xfrm>
            <a:off x="603682" y="6374168"/>
            <a:ext cx="85154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sz="1000" kern="1200" noProof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est plot of risk difference (RD) for pulmonary embolism (PE) among COVID-19 patients compared to non-COVID-19 patients in emergency </a:t>
            </a:r>
            <a:r>
              <a:rPr lang="en-US" sz="1000" kern="1200" noProof="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ard.</a:t>
            </a:r>
            <a:endParaRPr lang="en-US" sz="1000" noProof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262968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>
            <a:extLst>
              <a:ext uri="{FF2B5EF4-FFF2-40B4-BE49-F238E27FC236}">
                <a16:creationId xmlns:a16="http://schemas.microsoft.com/office/drawing/2014/main" xmlns="" id="{1B6C2695-4323-AB4E-A6DA-39E4BCF7F8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2154" y="3885503"/>
            <a:ext cx="4573871" cy="1701800"/>
          </a:xfrm>
          <a:prstGeom prst="rect">
            <a:avLst/>
          </a:prstGeom>
        </p:spPr>
      </p:pic>
      <p:pic>
        <p:nvPicPr>
          <p:cNvPr id="11" name="Immagine 10">
            <a:extLst>
              <a:ext uri="{FF2B5EF4-FFF2-40B4-BE49-F238E27FC236}">
                <a16:creationId xmlns:a16="http://schemas.microsoft.com/office/drawing/2014/main" xmlns="" id="{A351E13A-F85F-8E4A-A5D1-38FCB936810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2155" y="284220"/>
            <a:ext cx="10489350" cy="3364502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xmlns="" id="{B5C32261-370A-4C8F-9EBA-090EAFB2B3B4}"/>
              </a:ext>
            </a:extLst>
          </p:cNvPr>
          <p:cNvSpPr txBox="1"/>
          <p:nvPr/>
        </p:nvSpPr>
        <p:spPr>
          <a:xfrm>
            <a:off x="408373" y="6365289"/>
            <a:ext cx="89675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sz="1000" kern="1200" noProof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est plot of risk difference (RD) for deep venous thrombosis (DVT) among COVID-19 patients compared to non-COVID-19 patients in prospective studies.</a:t>
            </a:r>
            <a:r>
              <a:rPr lang="en-US" sz="1000" noProof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000" noProof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974462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xmlns="" id="{64EFF39B-5325-5C49-A1E3-6C4D7603E2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79100" y="2450230"/>
            <a:ext cx="4826000" cy="938540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xmlns="" id="{DF432139-EE45-C64D-B75D-1A437DFB2D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50236" y="44381"/>
            <a:ext cx="8935313" cy="2569530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xmlns="" id="{54747DCE-719A-2443-BA7F-6E34D739803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34019" y="5335478"/>
            <a:ext cx="4575154" cy="974450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xmlns="" id="{74308AC7-E180-9340-9ACF-C961E24F399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21636" y="3400147"/>
            <a:ext cx="8935313" cy="2165720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xmlns="" id="{5BEC9A31-566C-4F79-BE76-FF847132B53A}"/>
              </a:ext>
            </a:extLst>
          </p:cNvPr>
          <p:cNvSpPr txBox="1"/>
          <p:nvPr/>
        </p:nvSpPr>
        <p:spPr>
          <a:xfrm>
            <a:off x="665810" y="6436305"/>
            <a:ext cx="1103495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kern="1200" noProof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pper box: Forest plot of risk difference (RD) for deep venous thrombosis (DVT) among COVID-19 patients compared to non-COVID-19 patients in intensive care unit. Lower box: </a:t>
            </a:r>
            <a:r>
              <a:rPr lang="en-US" sz="1000" noProof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kern="1200" noProof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est plot of risk difference (RD) for deep venous thrombosis (DVT) among COVID-19 patients compared to non-COVID-19 patients affected by influenza.</a:t>
            </a:r>
            <a:r>
              <a:rPr lang="en-US" sz="1000" noProof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660007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1</TotalTime>
  <Words>448</Words>
  <Application>Microsoft Office PowerPoint</Application>
  <PresentationFormat>Widescreen</PresentationFormat>
  <Paragraphs>27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IA VARGAS</dc:creator>
  <cp:lastModifiedBy>MDPI</cp:lastModifiedBy>
  <cp:revision>35</cp:revision>
  <cp:lastPrinted>2021-10-22T09:58:03Z</cp:lastPrinted>
  <dcterms:created xsi:type="dcterms:W3CDTF">2021-06-10T07:20:20Z</dcterms:created>
  <dcterms:modified xsi:type="dcterms:W3CDTF">2021-10-25T10:39:23Z</dcterms:modified>
</cp:coreProperties>
</file>